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EF9FC-E5F9-4DA9-8FF9-B0E08DA87D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64156-2BC8-4DB0-A26F-2F599273D3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35C79-A459-4AC5-9287-D7947498D4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04820-E86D-4883-B8B4-88F359F5E5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83A1A-F1DF-4E8F-8324-CC1E547795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43030-8787-44FB-A36D-DBE64258F8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94AF7-027A-479E-98FD-3CD4777724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17401-08A7-4674-AC9F-3E3405F805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F8C2A-A0CF-45A0-9E1A-016B3094AD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A4178-581B-4E3B-A4F1-3CF4EB8D59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380C2-A8D7-4D99-862A-58A5D3A610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EA1DF-0982-4183-A80A-98627EB3B1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4BFF92-268D-4E5E-8152-90FD0958A557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2"/>
          <p:cNvSpPr/>
          <p:nvPr/>
        </p:nvSpPr>
        <p:spPr>
          <a:xfrm>
            <a:off x="5079960" y="34920"/>
            <a:ext cx="202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eh_ Supplement Fig. S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群組 1"/>
          <p:cNvGrpSpPr/>
          <p:nvPr/>
        </p:nvGrpSpPr>
        <p:grpSpPr>
          <a:xfrm>
            <a:off x="2276640" y="2340000"/>
            <a:ext cx="2841480" cy="2017440"/>
            <a:chOff x="2276640" y="2340000"/>
            <a:chExt cx="2841480" cy="2017440"/>
          </a:xfrm>
        </p:grpSpPr>
        <p:pic>
          <p:nvPicPr>
            <p:cNvPr id="43" name="Picture 6" descr="G:\The second paper progress(20140826)\20150129-2-actin-2.tif"/>
            <p:cNvPicPr/>
            <p:nvPr/>
          </p:nvPicPr>
          <p:blipFill>
            <a:blip r:embed="rId1"/>
            <a:srcRect l="7034" t="4500" r="1545" b="14000"/>
            <a:stretch/>
          </p:blipFill>
          <p:spPr>
            <a:xfrm>
              <a:off x="2276640" y="4141800"/>
              <a:ext cx="158256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44" name="Picture 7" descr="G:\The second paper progress(20140826)\20150129-2-hif1a-1.tif"/>
            <p:cNvPicPr/>
            <p:nvPr/>
          </p:nvPicPr>
          <p:blipFill>
            <a:blip r:embed="rId2"/>
            <a:srcRect l="6710" t="5102" r="3843" b="10034"/>
            <a:stretch/>
          </p:blipFill>
          <p:spPr>
            <a:xfrm>
              <a:off x="2276640" y="3925800"/>
              <a:ext cx="158256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45" name="Picture 10" descr="G:\The second paper progress(20140826)\20150129-2-hif1a-4.tif"/>
            <p:cNvPicPr/>
            <p:nvPr/>
          </p:nvPicPr>
          <p:blipFill>
            <a:blip r:embed="rId3"/>
            <a:srcRect l="8462" t="14499" r="4152" b="11659"/>
            <a:stretch/>
          </p:blipFill>
          <p:spPr>
            <a:xfrm>
              <a:off x="2276640" y="3433680"/>
              <a:ext cx="158256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46" name="Text Box 14"/>
            <p:cNvSpPr/>
            <p:nvPr/>
          </p:nvSpPr>
          <p:spPr>
            <a:xfrm>
              <a:off x="3864240" y="4141800"/>
              <a:ext cx="455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文字方塊 131"/>
            <p:cNvSpPr/>
            <p:nvPr/>
          </p:nvSpPr>
          <p:spPr>
            <a:xfrm>
              <a:off x="3864240" y="2878200"/>
              <a:ext cx="66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Fibrone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文字方塊 131"/>
            <p:cNvSpPr/>
            <p:nvPr/>
          </p:nvSpPr>
          <p:spPr>
            <a:xfrm>
              <a:off x="3864240" y="3406680"/>
              <a:ext cx="50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F-1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文字方塊 131"/>
            <p:cNvSpPr/>
            <p:nvPr/>
          </p:nvSpPr>
          <p:spPr>
            <a:xfrm>
              <a:off x="3864240" y="3917880"/>
              <a:ext cx="574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F-1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文字方塊 17"/>
            <p:cNvSpPr/>
            <p:nvPr/>
          </p:nvSpPr>
          <p:spPr>
            <a:xfrm>
              <a:off x="2300400" y="267948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文字方塊 18"/>
            <p:cNvSpPr/>
            <p:nvPr/>
          </p:nvSpPr>
          <p:spPr>
            <a:xfrm>
              <a:off x="2487600" y="2679480"/>
              <a:ext cx="23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文字方塊 19"/>
            <p:cNvSpPr/>
            <p:nvPr/>
          </p:nvSpPr>
          <p:spPr>
            <a:xfrm>
              <a:off x="2673360" y="267804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文字方塊 20"/>
            <p:cNvSpPr/>
            <p:nvPr/>
          </p:nvSpPr>
          <p:spPr>
            <a:xfrm>
              <a:off x="2859120" y="267804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文字方塊 21"/>
            <p:cNvSpPr/>
            <p:nvPr/>
          </p:nvSpPr>
          <p:spPr>
            <a:xfrm>
              <a:off x="3046320" y="2678040"/>
              <a:ext cx="23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文字方塊 22"/>
            <p:cNvSpPr/>
            <p:nvPr/>
          </p:nvSpPr>
          <p:spPr>
            <a:xfrm>
              <a:off x="3232080" y="267804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文字方塊 23"/>
            <p:cNvSpPr/>
            <p:nvPr/>
          </p:nvSpPr>
          <p:spPr>
            <a:xfrm>
              <a:off x="3419640" y="2678040"/>
              <a:ext cx="23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文字方塊 24"/>
            <p:cNvSpPr/>
            <p:nvPr/>
          </p:nvSpPr>
          <p:spPr>
            <a:xfrm>
              <a:off x="3605400" y="2678040"/>
              <a:ext cx="23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文字方塊 26"/>
            <p:cNvSpPr/>
            <p:nvPr/>
          </p:nvSpPr>
          <p:spPr>
            <a:xfrm>
              <a:off x="2595600" y="2340000"/>
              <a:ext cx="1209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% O</a:t>
              </a:r>
              <a:r>
                <a:rPr b="0" lang="en-US" sz="5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  Hypoxia TM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文字方塊 35"/>
            <p:cNvSpPr/>
            <p:nvPr/>
          </p:nvSpPr>
          <p:spPr>
            <a:xfrm>
              <a:off x="3880080" y="2678040"/>
              <a:ext cx="431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直線接點 19"/>
            <p:cNvSpPr/>
            <p:nvPr/>
          </p:nvSpPr>
          <p:spPr>
            <a:xfrm>
              <a:off x="2363760" y="270036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直線接點 20"/>
            <p:cNvSpPr/>
            <p:nvPr/>
          </p:nvSpPr>
          <p:spPr>
            <a:xfrm>
              <a:off x="2736720" y="270036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直線接點 21"/>
            <p:cNvSpPr/>
            <p:nvPr/>
          </p:nvSpPr>
          <p:spPr>
            <a:xfrm>
              <a:off x="3102120" y="270036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直線接點 22"/>
            <p:cNvSpPr/>
            <p:nvPr/>
          </p:nvSpPr>
          <p:spPr>
            <a:xfrm>
              <a:off x="3478320" y="270180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文字方塊 41"/>
            <p:cNvSpPr/>
            <p:nvPr/>
          </p:nvSpPr>
          <p:spPr>
            <a:xfrm>
              <a:off x="2378160" y="2523960"/>
              <a:ext cx="299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文字方塊 42"/>
            <p:cNvSpPr/>
            <p:nvPr/>
          </p:nvSpPr>
          <p:spPr>
            <a:xfrm>
              <a:off x="2787840" y="2535120"/>
              <a:ext cx="299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文字方塊 43"/>
            <p:cNvSpPr/>
            <p:nvPr/>
          </p:nvSpPr>
          <p:spPr>
            <a:xfrm>
              <a:off x="3146400" y="2533680"/>
              <a:ext cx="301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9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文字方塊 44"/>
            <p:cNvSpPr/>
            <p:nvPr/>
          </p:nvSpPr>
          <p:spPr>
            <a:xfrm>
              <a:off x="3489480" y="2535120"/>
              <a:ext cx="299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文字方塊 52"/>
            <p:cNvSpPr/>
            <p:nvPr/>
          </p:nvSpPr>
          <p:spPr>
            <a:xfrm>
              <a:off x="3851280" y="2523960"/>
              <a:ext cx="55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our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9" name="Picture 2" descr="G:\The second paper progress(20140826)\20150129-2-fn-1.tif"/>
            <p:cNvPicPr/>
            <p:nvPr/>
          </p:nvPicPr>
          <p:blipFill>
            <a:blip r:embed="rId4"/>
            <a:srcRect l="11733" t="0" r="3628" b="18978"/>
            <a:stretch/>
          </p:blipFill>
          <p:spPr>
            <a:xfrm>
              <a:off x="2281320" y="2900160"/>
              <a:ext cx="158256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70" name="文字方塊 3"/>
            <p:cNvSpPr/>
            <p:nvPr/>
          </p:nvSpPr>
          <p:spPr>
            <a:xfrm>
              <a:off x="2282760" y="3197160"/>
              <a:ext cx="1744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1      0.51   0.66   1.00   0.66     0.71   0.41   0.5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文字方塊 58"/>
            <p:cNvSpPr/>
            <p:nvPr/>
          </p:nvSpPr>
          <p:spPr>
            <a:xfrm>
              <a:off x="2301840" y="3720960"/>
              <a:ext cx="17254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1      0.72   0.77   0.93   0.72  1.03    0.87   0.8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直線接點 32"/>
            <p:cNvSpPr/>
            <p:nvPr/>
          </p:nvSpPr>
          <p:spPr>
            <a:xfrm>
              <a:off x="2276640" y="2536560"/>
              <a:ext cx="1608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文字方塊 3"/>
            <p:cNvSpPr/>
            <p:nvPr/>
          </p:nvSpPr>
          <p:spPr>
            <a:xfrm>
              <a:off x="2282760" y="3090960"/>
              <a:ext cx="1744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      0.51 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.51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.07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.3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文字方塊 58"/>
            <p:cNvSpPr/>
            <p:nvPr/>
          </p:nvSpPr>
          <p:spPr>
            <a:xfrm>
              <a:off x="2298600" y="3621240"/>
              <a:ext cx="1657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      0.72  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  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.21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.43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r>
                <a:rPr b="1" lang="zh-TW" sz="600" spc="-1" strike="noStrike">
                  <a:solidFill>
                    <a:srgbClr val="000000"/>
                  </a:solidFill>
                  <a:latin typeface="Calibri"/>
                </a:rPr>
                <a:t>      </a:t>
              </a:r>
              <a:r>
                <a:rPr b="1" lang="en-US" sz="600" spc="-1" strike="noStrike">
                  <a:solidFill>
                    <a:srgbClr val="000000"/>
                  </a:solidFill>
                  <a:latin typeface="Calibri"/>
                </a:rPr>
                <a:t>0.9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直線接點 36"/>
            <p:cNvSpPr/>
            <p:nvPr/>
          </p:nvSpPr>
          <p:spPr>
            <a:xfrm>
              <a:off x="2363760" y="311940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直線接點 37"/>
            <p:cNvSpPr/>
            <p:nvPr/>
          </p:nvSpPr>
          <p:spPr>
            <a:xfrm>
              <a:off x="2736720" y="311940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直線接點 38"/>
            <p:cNvSpPr/>
            <p:nvPr/>
          </p:nvSpPr>
          <p:spPr>
            <a:xfrm>
              <a:off x="3102120" y="311940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直線接點 39"/>
            <p:cNvSpPr/>
            <p:nvPr/>
          </p:nvSpPr>
          <p:spPr>
            <a:xfrm>
              <a:off x="3478320" y="311940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直線接點 40"/>
            <p:cNvSpPr/>
            <p:nvPr/>
          </p:nvSpPr>
          <p:spPr>
            <a:xfrm>
              <a:off x="2363760" y="365436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直線接點 41"/>
            <p:cNvSpPr/>
            <p:nvPr/>
          </p:nvSpPr>
          <p:spPr>
            <a:xfrm>
              <a:off x="2736720" y="3654360"/>
              <a:ext cx="32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直線接點 42"/>
            <p:cNvSpPr/>
            <p:nvPr/>
          </p:nvSpPr>
          <p:spPr>
            <a:xfrm>
              <a:off x="3102120" y="3654360"/>
              <a:ext cx="32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直線接點 43"/>
            <p:cNvSpPr/>
            <p:nvPr/>
          </p:nvSpPr>
          <p:spPr>
            <a:xfrm>
              <a:off x="3478320" y="3654360"/>
              <a:ext cx="32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文字方塊 131"/>
            <p:cNvSpPr/>
            <p:nvPr/>
          </p:nvSpPr>
          <p:spPr>
            <a:xfrm>
              <a:off x="3795840" y="3081240"/>
              <a:ext cx="790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Relative expression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文字方塊 131"/>
            <p:cNvSpPr/>
            <p:nvPr/>
          </p:nvSpPr>
          <p:spPr>
            <a:xfrm>
              <a:off x="3878280" y="3613320"/>
              <a:ext cx="863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Relative expression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文字方塊 46"/>
            <p:cNvSpPr/>
            <p:nvPr/>
          </p:nvSpPr>
          <p:spPr>
            <a:xfrm>
              <a:off x="4181760" y="3411360"/>
              <a:ext cx="93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(Longer exposure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文字方塊 47"/>
            <p:cNvSpPr/>
            <p:nvPr/>
          </p:nvSpPr>
          <p:spPr>
            <a:xfrm>
              <a:off x="4181760" y="3908520"/>
              <a:ext cx="936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(shorter exposure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文字方塊 131"/>
            <p:cNvSpPr/>
            <p:nvPr/>
          </p:nvSpPr>
          <p:spPr>
            <a:xfrm>
              <a:off x="3792600" y="3201840"/>
              <a:ext cx="431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(Folds)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文字方塊 131"/>
            <p:cNvSpPr/>
            <p:nvPr/>
          </p:nvSpPr>
          <p:spPr>
            <a:xfrm>
              <a:off x="3792600" y="3713040"/>
              <a:ext cx="431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(Folds)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8T07:00:22Z</dcterms:created>
  <dc:creator>yeh</dc:creator>
  <dc:description/>
  <dc:language>en-US</dc:language>
  <cp:lastModifiedBy>Abella, Jerard Dave</cp:lastModifiedBy>
  <dcterms:modified xsi:type="dcterms:W3CDTF">2018-03-13T10:51:49Z</dcterms:modified>
  <cp:revision>24</cp:revision>
  <dc:subject/>
  <dc:title>PowerPoint 簡報</dc:title>
</cp:coreProperties>
</file>